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779931-41FF-40ED-BAC2-4E802EDE92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E32031-D2B0-4DF6-9CF9-A4430F61BE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F186F8-6D35-47E3-88D6-9CC17224E2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EAEEFF-D32C-44F5-A1BA-FF36E198725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B5CB03-7216-458E-93F4-9E623591D9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1F5BE-07D9-4A66-AFD5-585D6CC30E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5603F6-2166-4D2F-B0F6-9F25148320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852927-178A-4239-8FF6-D4C032D298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356C10-2B66-4769-8C13-7DD65F4FA7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53739-7357-430F-B5C2-085C1E3729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8577B-FC43-4A35-AAFC-367185A20C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86447D-FEA6-464F-86C7-5AF9481A6E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7D1D25-3E76-4557-A84B-8828544C4068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D6B185-9995-48DD-8D2F-53623D47ADC1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図形グループ 52"/>
          <p:cNvGrpSpPr/>
          <p:nvPr/>
        </p:nvGrpSpPr>
        <p:grpSpPr>
          <a:xfrm>
            <a:off x="2819520" y="2362320"/>
            <a:ext cx="4271760" cy="1724760"/>
            <a:chOff x="2819520" y="2362320"/>
            <a:chExt cx="4271760" cy="1724760"/>
          </a:xfrm>
        </p:grpSpPr>
        <p:sp>
          <p:nvSpPr>
            <p:cNvPr id="42" name="Text Box 5"/>
            <p:cNvSpPr/>
            <p:nvPr/>
          </p:nvSpPr>
          <p:spPr>
            <a:xfrm>
              <a:off x="3781440" y="3044880"/>
              <a:ext cx="714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6"/>
            <p:cNvSpPr/>
            <p:nvPr/>
          </p:nvSpPr>
          <p:spPr>
            <a:xfrm>
              <a:off x="4264920" y="3046320"/>
              <a:ext cx="701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6"/>
            <p:cNvSpPr/>
            <p:nvPr/>
          </p:nvSpPr>
          <p:spPr>
            <a:xfrm>
              <a:off x="4653000" y="3046320"/>
              <a:ext cx="569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6"/>
            <p:cNvSpPr/>
            <p:nvPr/>
          </p:nvSpPr>
          <p:spPr>
            <a:xfrm>
              <a:off x="5186520" y="3046320"/>
              <a:ext cx="569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6"/>
            <p:cNvSpPr/>
            <p:nvPr/>
          </p:nvSpPr>
          <p:spPr>
            <a:xfrm rot="16200000">
              <a:off x="2986200" y="2693520"/>
              <a:ext cx="1000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buff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テキスト ボックス 11"/>
            <p:cNvSpPr/>
            <p:nvPr/>
          </p:nvSpPr>
          <p:spPr>
            <a:xfrm>
              <a:off x="5567400" y="3749760"/>
              <a:ext cx="928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-act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テキスト ボックス 17"/>
            <p:cNvSpPr/>
            <p:nvPr/>
          </p:nvSpPr>
          <p:spPr>
            <a:xfrm>
              <a:off x="5519880" y="3013200"/>
              <a:ext cx="1571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(ng/ml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9" name="Picture 26" descr=""/>
            <p:cNvPicPr/>
            <p:nvPr/>
          </p:nvPicPr>
          <p:blipFill>
            <a:blip r:embed="rId1"/>
            <a:stretch/>
          </p:blipFill>
          <p:spPr>
            <a:xfrm>
              <a:off x="2819520" y="3930840"/>
              <a:ext cx="2742840" cy="14760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sp>
          <p:nvSpPr>
            <p:cNvPr id="50" name="二等辺三角形 24"/>
            <p:cNvSpPr/>
            <p:nvPr/>
          </p:nvSpPr>
          <p:spPr>
            <a:xfrm rot="16200000">
              <a:off x="5763960" y="3438360"/>
              <a:ext cx="142560" cy="2854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1" name="図 25" descr=""/>
            <p:cNvPicPr/>
            <p:nvPr/>
          </p:nvPicPr>
          <p:blipFill>
            <a:blip r:embed="rId2"/>
            <a:stretch/>
          </p:blipFill>
          <p:spPr>
            <a:xfrm>
              <a:off x="2819520" y="3354480"/>
              <a:ext cx="2755440" cy="45396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sp>
          <p:nvSpPr>
            <p:cNvPr id="52" name="直線コネクタ 257"/>
            <p:cNvSpPr/>
            <p:nvPr/>
          </p:nvSpPr>
          <p:spPr>
            <a:xfrm>
              <a:off x="3814560" y="3044880"/>
              <a:ext cx="7776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直線コネクタ 257"/>
            <p:cNvSpPr/>
            <p:nvPr/>
          </p:nvSpPr>
          <p:spPr>
            <a:xfrm>
              <a:off x="4751280" y="3044880"/>
              <a:ext cx="7776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テキスト ボックス 17"/>
            <p:cNvSpPr/>
            <p:nvPr/>
          </p:nvSpPr>
          <p:spPr>
            <a:xfrm>
              <a:off x="3967200" y="2706120"/>
              <a:ext cx="504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w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テキスト ボックス 17"/>
            <p:cNvSpPr/>
            <p:nvPr/>
          </p:nvSpPr>
          <p:spPr>
            <a:xfrm>
              <a:off x="4743000" y="2706120"/>
              <a:ext cx="936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C1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56" name="Picture 2" descr=""/>
          <p:cNvPicPr/>
          <p:nvPr/>
        </p:nvPicPr>
        <p:blipFill>
          <a:blip r:embed="rId3"/>
          <a:stretch/>
        </p:blipFill>
        <p:spPr>
          <a:xfrm>
            <a:off x="1360440" y="2365200"/>
            <a:ext cx="685800" cy="24609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57" name="Text Box 4"/>
          <p:cNvSpPr/>
          <p:nvPr/>
        </p:nvSpPr>
        <p:spPr>
          <a:xfrm>
            <a:off x="1447920" y="2085840"/>
            <a:ext cx="64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5"/>
          <p:cNvSpPr/>
          <p:nvPr/>
        </p:nvSpPr>
        <p:spPr>
          <a:xfrm>
            <a:off x="1716120" y="2085840"/>
            <a:ext cx="874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∆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8"/>
          <p:cNvSpPr/>
          <p:nvPr/>
        </p:nvSpPr>
        <p:spPr>
          <a:xfrm>
            <a:off x="838080" y="3124080"/>
            <a:ext cx="75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9"/>
          <p:cNvSpPr/>
          <p:nvPr/>
        </p:nvSpPr>
        <p:spPr>
          <a:xfrm>
            <a:off x="838080" y="2971800"/>
            <a:ext cx="75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0"/>
          <p:cNvSpPr/>
          <p:nvPr/>
        </p:nvSpPr>
        <p:spPr>
          <a:xfrm>
            <a:off x="838080" y="208584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58"/>
          <p:cNvSpPr/>
          <p:nvPr/>
        </p:nvSpPr>
        <p:spPr>
          <a:xfrm>
            <a:off x="1143000" y="4876920"/>
            <a:ext cx="191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ゴシック"/>
              </a:rPr>
              <a:t>CBB stain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図形グループ 67"/>
          <p:cNvGrpSpPr/>
          <p:nvPr/>
        </p:nvGrpSpPr>
        <p:grpSpPr>
          <a:xfrm>
            <a:off x="838080" y="3686040"/>
            <a:ext cx="755640" cy="276480"/>
            <a:chOff x="838080" y="3686040"/>
            <a:chExt cx="755640" cy="276480"/>
          </a:xfrm>
        </p:grpSpPr>
        <p:sp>
          <p:nvSpPr>
            <p:cNvPr id="64" name="Text Box 7"/>
            <p:cNvSpPr/>
            <p:nvPr/>
          </p:nvSpPr>
          <p:spPr>
            <a:xfrm>
              <a:off x="838080" y="3686040"/>
              <a:ext cx="75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直線コネクタ 61"/>
            <p:cNvSpPr/>
            <p:nvPr/>
          </p:nvSpPr>
          <p:spPr>
            <a:xfrm>
              <a:off x="1143000" y="3834000"/>
              <a:ext cx="15228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直線コネクタ 63"/>
          <p:cNvSpPr/>
          <p:nvPr/>
        </p:nvSpPr>
        <p:spPr>
          <a:xfrm>
            <a:off x="1143000" y="3124080"/>
            <a:ext cx="15228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直線コネクタ 64"/>
          <p:cNvSpPr/>
          <p:nvPr/>
        </p:nvSpPr>
        <p:spPr>
          <a:xfrm>
            <a:off x="1143000" y="3276720"/>
            <a:ext cx="15228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図形グループ 66"/>
          <p:cNvGrpSpPr/>
          <p:nvPr/>
        </p:nvGrpSpPr>
        <p:grpSpPr>
          <a:xfrm>
            <a:off x="838080" y="3381480"/>
            <a:ext cx="755640" cy="276480"/>
            <a:chOff x="838080" y="3381480"/>
            <a:chExt cx="755640" cy="276480"/>
          </a:xfrm>
        </p:grpSpPr>
        <p:sp>
          <p:nvSpPr>
            <p:cNvPr id="69" name="Text Box 6"/>
            <p:cNvSpPr/>
            <p:nvPr/>
          </p:nvSpPr>
          <p:spPr>
            <a:xfrm>
              <a:off x="838080" y="3381480"/>
              <a:ext cx="75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直線コネクタ 65"/>
            <p:cNvSpPr/>
            <p:nvPr/>
          </p:nvSpPr>
          <p:spPr>
            <a:xfrm>
              <a:off x="1143000" y="3533760"/>
              <a:ext cx="15228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1" name="Text Box 58"/>
          <p:cNvSpPr/>
          <p:nvPr/>
        </p:nvSpPr>
        <p:spPr>
          <a:xfrm>
            <a:off x="609480" y="152388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ゴシック"/>
              </a:rPr>
              <a:t>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58"/>
          <p:cNvSpPr/>
          <p:nvPr/>
        </p:nvSpPr>
        <p:spPr>
          <a:xfrm>
            <a:off x="3200400" y="152388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ゴシック"/>
              </a:rPr>
              <a:t>B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テキスト ボックス 3"/>
          <p:cNvSpPr/>
          <p:nvPr/>
        </p:nvSpPr>
        <p:spPr>
          <a:xfrm>
            <a:off x="100080" y="228600"/>
            <a:ext cx="3024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4"/>
          <p:cNvSpPr/>
          <p:nvPr/>
        </p:nvSpPr>
        <p:spPr>
          <a:xfrm>
            <a:off x="512640" y="5435640"/>
            <a:ext cx="6019920" cy="19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14. L1-RTP by Vpr required a carboxy-terminal reg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.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　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Purification of rVpr and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Δ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12. Each rVpr were purified using two-step column chromatography at the same time. Purified proteins were stained with Coomassie brilliant blue (CBB).  B. Dependence of rVpr induced L1-RTP on its C-terminal region. HuH-7 cells were transfected with pEF06R and selected with Puro. Replated cells were treated with indicated amouts of either Wt or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Δ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12 of rVpr for 2days. rVpr induced L1-RTP was analyzed by PCR based assay. Apparent L1-RTP induction was not observed by C-terminus truncated rVpr treatme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7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2T00:59:02Z</dcterms:created>
  <dc:creator>奥平准之</dc:creator>
  <dc:description/>
  <dc:language>en-US</dc:language>
  <cp:lastModifiedBy>Santos, Noribeth</cp:lastModifiedBy>
  <cp:lastPrinted>2013-06-12T04:06:08Z</cp:lastPrinted>
  <dcterms:modified xsi:type="dcterms:W3CDTF">2013-06-14T07:57:41Z</dcterms:modified>
  <cp:revision>1633</cp:revision>
  <dc:subject/>
  <dc:title>スライド 1</dc:title>
</cp:coreProperties>
</file>